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69" r:id="rId2"/>
    <p:sldId id="270" r:id="rId3"/>
    <p:sldId id="271" r:id="rId4"/>
    <p:sldId id="268" r:id="rId5"/>
    <p:sldId id="267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7"/>
    <p:restoredTop sz="94669"/>
  </p:normalViewPr>
  <p:slideViewPr>
    <p:cSldViewPr snapToGrid="0">
      <p:cViewPr varScale="1">
        <p:scale>
          <a:sx n="85" d="100"/>
          <a:sy n="85" d="100"/>
        </p:scale>
        <p:origin x="324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BC0DD6-6EF3-5B46-AA6A-FB80E94A888D}" type="datetimeFigureOut">
              <a:rPr lang="en-US" smtClean="0"/>
              <a:t>7/1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C3B682-E9C4-EF49-B5F0-301C40E39A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9534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C3B682-E9C4-EF49-B5F0-301C40E39A8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5029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73A8C-50C8-47EF-B52A-A796A310BCA9}" type="datetimeFigureOut">
              <a:rPr lang="en-SG" smtClean="0"/>
              <a:t>13/7/23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53179-438B-4D38-93B4-9B4F1150B4C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079631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73A8C-50C8-47EF-B52A-A796A310BCA9}" type="datetimeFigureOut">
              <a:rPr lang="en-SG" smtClean="0"/>
              <a:t>13/7/23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53179-438B-4D38-93B4-9B4F1150B4C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80616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73A8C-50C8-47EF-B52A-A796A310BCA9}" type="datetimeFigureOut">
              <a:rPr lang="en-SG" smtClean="0"/>
              <a:t>13/7/23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53179-438B-4D38-93B4-9B4F1150B4C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311869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73A8C-50C8-47EF-B52A-A796A310BCA9}" type="datetimeFigureOut">
              <a:rPr lang="en-SG" smtClean="0"/>
              <a:t>13/7/23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53179-438B-4D38-93B4-9B4F1150B4C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816684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73A8C-50C8-47EF-B52A-A796A310BCA9}" type="datetimeFigureOut">
              <a:rPr lang="en-SG" smtClean="0"/>
              <a:t>13/7/23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53179-438B-4D38-93B4-9B4F1150B4C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283391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73A8C-50C8-47EF-B52A-A796A310BCA9}" type="datetimeFigureOut">
              <a:rPr lang="en-SG" smtClean="0"/>
              <a:t>13/7/23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53179-438B-4D38-93B4-9B4F1150B4C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266791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73A8C-50C8-47EF-B52A-A796A310BCA9}" type="datetimeFigureOut">
              <a:rPr lang="en-SG" smtClean="0"/>
              <a:t>13/7/23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53179-438B-4D38-93B4-9B4F1150B4C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446503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73A8C-50C8-47EF-B52A-A796A310BCA9}" type="datetimeFigureOut">
              <a:rPr lang="en-SG" smtClean="0"/>
              <a:t>13/7/23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53179-438B-4D38-93B4-9B4F1150B4C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536405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73A8C-50C8-47EF-B52A-A796A310BCA9}" type="datetimeFigureOut">
              <a:rPr lang="en-SG" smtClean="0"/>
              <a:t>13/7/23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53179-438B-4D38-93B4-9B4F1150B4C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637363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73A8C-50C8-47EF-B52A-A796A310BCA9}" type="datetimeFigureOut">
              <a:rPr lang="en-SG" smtClean="0"/>
              <a:t>13/7/23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53179-438B-4D38-93B4-9B4F1150B4C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876396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373A8C-50C8-47EF-B52A-A796A310BCA9}" type="datetimeFigureOut">
              <a:rPr lang="en-SG" smtClean="0"/>
              <a:t>13/7/23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53179-438B-4D38-93B4-9B4F1150B4C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762984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373A8C-50C8-47EF-B52A-A796A310BCA9}" type="datetimeFigureOut">
              <a:rPr lang="en-SG" smtClean="0"/>
              <a:t>13/7/23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53179-438B-4D38-93B4-9B4F1150B4CC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7044575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482CB4D-958E-35BC-BF50-3788D4893427}"/>
              </a:ext>
            </a:extLst>
          </p:cNvPr>
          <p:cNvSpPr txBox="1"/>
          <p:nvPr/>
        </p:nvSpPr>
        <p:spPr>
          <a:xfrm>
            <a:off x="37161" y="0"/>
            <a:ext cx="2649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pic>
        <p:nvPicPr>
          <p:cNvPr id="5" name="Picture 4" descr="A picture containing text, screenshot, diagram, design&#10;&#10;Description automatically generated">
            <a:extLst>
              <a:ext uri="{FF2B5EF4-FFF2-40B4-BE49-F238E27FC236}">
                <a16:creationId xmlns:a16="http://schemas.microsoft.com/office/drawing/2014/main" id="{769B8DC3-710D-B9CD-E560-9E61F57F49B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9492" y="1278636"/>
            <a:ext cx="4319016" cy="65867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65495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F4BA273-1D28-1B49-6246-306DAFCE456B}"/>
              </a:ext>
            </a:extLst>
          </p:cNvPr>
          <p:cNvSpPr txBox="1"/>
          <p:nvPr/>
        </p:nvSpPr>
        <p:spPr>
          <a:xfrm>
            <a:off x="37161" y="0"/>
            <a:ext cx="2649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pic>
        <p:nvPicPr>
          <p:cNvPr id="6" name="Picture 5" descr="A picture containing text, screenshot, diagram&#10;&#10;Description automatically generated">
            <a:extLst>
              <a:ext uri="{FF2B5EF4-FFF2-40B4-BE49-F238E27FC236}">
                <a16:creationId xmlns:a16="http://schemas.microsoft.com/office/drawing/2014/main" id="{69FB3404-F006-51EB-6707-EF5E365CD3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2045" y="1700530"/>
            <a:ext cx="4318000" cy="3822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82530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F4BA273-1D28-1B49-6246-306DAFCE456B}"/>
              </a:ext>
            </a:extLst>
          </p:cNvPr>
          <p:cNvSpPr txBox="1"/>
          <p:nvPr/>
        </p:nvSpPr>
        <p:spPr>
          <a:xfrm>
            <a:off x="37161" y="0"/>
            <a:ext cx="2649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pic>
        <p:nvPicPr>
          <p:cNvPr id="4" name="Picture 3" descr="A picture containing text, screenshot, diagram, plan&#10;&#10;Description automatically generated">
            <a:extLst>
              <a:ext uri="{FF2B5EF4-FFF2-40B4-BE49-F238E27FC236}">
                <a16:creationId xmlns:a16="http://schemas.microsoft.com/office/drawing/2014/main" id="{721D66BE-11E7-3E4B-26CC-B64A134953D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700" y="1282700"/>
            <a:ext cx="6578600" cy="6578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04160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AE1CE65-545F-9CC9-CCC5-A6CAF6EC3AEB}"/>
              </a:ext>
            </a:extLst>
          </p:cNvPr>
          <p:cNvSpPr txBox="1"/>
          <p:nvPr/>
        </p:nvSpPr>
        <p:spPr>
          <a:xfrm>
            <a:off x="37161" y="0"/>
            <a:ext cx="2649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C3EAE8C6-05D7-C4BD-A62C-DD7972D9A7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400" y="1779793"/>
            <a:ext cx="6577200" cy="55844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31452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screenshot, diagram, font&#10;&#10;Description automatically generated">
            <a:extLst>
              <a:ext uri="{FF2B5EF4-FFF2-40B4-BE49-F238E27FC236}">
                <a16:creationId xmlns:a16="http://schemas.microsoft.com/office/drawing/2014/main" id="{A2168629-66E0-7B1B-A609-2CCD5E0C44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9492" y="2720340"/>
            <a:ext cx="4319016" cy="370332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5DC8B9A-6C67-45F6-4B91-ECA4F7F37BCD}"/>
              </a:ext>
            </a:extLst>
          </p:cNvPr>
          <p:cNvSpPr txBox="1"/>
          <p:nvPr/>
        </p:nvSpPr>
        <p:spPr>
          <a:xfrm>
            <a:off x="37161" y="0"/>
            <a:ext cx="2649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3561772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608</TotalTime>
  <Words>16</Words>
  <Application>Microsoft Macintosh PowerPoint</Application>
  <PresentationFormat>Letter Paper (8.5x11 in)</PresentationFormat>
  <Paragraphs>6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ng Zi Tan</dc:creator>
  <cp:lastModifiedBy>Sriram Aiyer</cp:lastModifiedBy>
  <cp:revision>27</cp:revision>
  <dcterms:created xsi:type="dcterms:W3CDTF">2023-05-02T18:49:41Z</dcterms:created>
  <dcterms:modified xsi:type="dcterms:W3CDTF">2023-07-14T05:57:36Z</dcterms:modified>
</cp:coreProperties>
</file>